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7" r:id="rId2"/>
    <p:sldId id="268" r:id="rId3"/>
    <p:sldId id="271" r:id="rId4"/>
    <p:sldId id="270" r:id="rId5"/>
    <p:sldId id="263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4A6"/>
    <a:srgbClr val="C413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44"/>
    <p:restoredTop sz="94787"/>
  </p:normalViewPr>
  <p:slideViewPr>
    <p:cSldViewPr snapToGrid="0">
      <p:cViewPr varScale="1">
        <p:scale>
          <a:sx n="81" d="100"/>
          <a:sy n="81" d="100"/>
        </p:scale>
        <p:origin x="114" y="30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imstreeb\Library\Mobile%20Documents\com~apple~CloudDocs\04%20|%20Publikation\01%20Arbeitsordner\UFR%20research%20area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imstreeb\Library\Mobile%20Documents\com~apple~CloudDocs\04%20|%20Publikation\01%20Arbeitsordner\UFR%20research%20area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imstreeb\Library\Mobile%20Documents\com~apple~CloudDocs\04%20|%20Publikation\01%20Arbeitsordner\UFR%20research%20area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de-DE" b="1" dirty="0">
                <a:solidFill>
                  <a:schemeClr val="tx1"/>
                </a:solidFill>
              </a:rPr>
              <a:t>ROC-like</a:t>
            </a:r>
            <a:r>
              <a:rPr lang="de-DE" b="1" baseline="0" dirty="0">
                <a:solidFill>
                  <a:schemeClr val="tx1"/>
                </a:solidFill>
              </a:rPr>
              <a:t> </a:t>
            </a:r>
            <a:r>
              <a:rPr lang="en-GB" b="1" baseline="0" noProof="0" dirty="0">
                <a:solidFill>
                  <a:schemeClr val="tx1"/>
                </a:solidFill>
              </a:rPr>
              <a:t>diagram</a:t>
            </a:r>
            <a:endParaRPr lang="en-GB" b="1" noProof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5180781577483777"/>
          <c:y val="1.74387195149187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(A) Complexity of Nature and Future Ecosystems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9243"/>
              </a:solidFill>
              <a:ln w="38100">
                <a:solidFill>
                  <a:srgbClr val="009243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Query 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176C-9743-9BEB-22E9D9D68763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Query2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76C-9743-9BEB-22E9D9D68763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Query</a:t>
                    </a:r>
                    <a:r>
                      <a:rPr lang="en-US" baseline="0"/>
                      <a:t> 3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76C-9743-9BEB-22E9D9D68763}"/>
                </c:ext>
              </c:extLst>
            </c:dLbl>
            <c:dLbl>
              <c:idx val="3"/>
              <c:layout>
                <c:manualLayout>
                  <c:x val="-0.13215475867883059"/>
                  <c:y val="-2.689583472519641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Query 4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76C-9743-9BEB-22E9D9D687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DE"/>
              </a:p>
            </c:txPr>
            <c:dLblPos val="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xVal>
            <c:numRef>
              <c:f>'(6) ROC diagram'!$C$4:$F$4</c:f>
              <c:numCache>
                <c:formatCode>0.0</c:formatCode>
                <c:ptCount val="4"/>
                <c:pt idx="0">
                  <c:v>0.68409090909090908</c:v>
                </c:pt>
                <c:pt idx="1">
                  <c:v>0.59139784946236562</c:v>
                </c:pt>
                <c:pt idx="2">
                  <c:v>0.6791171477079796</c:v>
                </c:pt>
                <c:pt idx="3">
                  <c:v>0.84918032786885245</c:v>
                </c:pt>
              </c:numCache>
            </c:numRef>
          </c:xVal>
          <c:yVal>
            <c:numRef>
              <c:f>'(6) ROC diagram'!$C$5:$F$5</c:f>
              <c:numCache>
                <c:formatCode>0.0</c:formatCode>
                <c:ptCount val="4"/>
                <c:pt idx="0">
                  <c:v>0.36103896103896105</c:v>
                </c:pt>
                <c:pt idx="1">
                  <c:v>0.19740259740259741</c:v>
                </c:pt>
                <c:pt idx="2">
                  <c:v>0.49090909090909091</c:v>
                </c:pt>
                <c:pt idx="3">
                  <c:v>0.836363636363636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76C-9743-9BEB-22E9D9D68763}"/>
            </c:ext>
          </c:extLst>
        </c:ser>
        <c:ser>
          <c:idx val="1"/>
          <c:order val="1"/>
          <c:tx>
            <c:v>(B) Data Analysis and Artificial Intelligenc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E5A400"/>
              </a:solidFill>
              <a:ln w="38100">
                <a:solidFill>
                  <a:srgbClr val="E5A400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Query</a:t>
                    </a:r>
                    <a:r>
                      <a:rPr lang="en-US" baseline="0"/>
                      <a:t> 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76C-9743-9BEB-22E9D9D68763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Query 2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176C-9743-9BEB-22E9D9D68763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Query 3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76C-9743-9BEB-22E9D9D68763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Query 4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176C-9743-9BEB-22E9D9D68763}"/>
                </c:ext>
              </c:extLst>
            </c:dLbl>
            <c:dLbl>
              <c:idx val="4"/>
              <c:layout>
                <c:manualLayout>
                  <c:x val="0"/>
                  <c:y val="3.870258435276315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Query 4</a:t>
                    </a:r>
                    <a:r>
                      <a:rPr lang="en-US" baseline="0"/>
                      <a:t> "NOT"</a:t>
                    </a:r>
                    <a:endParaRPr lang="en-US"/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76C-9743-9BEB-22E9D9D687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DE"/>
              </a:p>
            </c:txPr>
            <c:dLblPos val="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(6) ROC diagram'!$G$4:$K$4</c:f>
              <c:numCache>
                <c:formatCode>0.0</c:formatCode>
                <c:ptCount val="5"/>
                <c:pt idx="0">
                  <c:v>0.89153754469606672</c:v>
                </c:pt>
                <c:pt idx="1">
                  <c:v>0.86956521739130432</c:v>
                </c:pt>
                <c:pt idx="2">
                  <c:v>0.89065606361829031</c:v>
                </c:pt>
                <c:pt idx="3">
                  <c:v>0.93268665490887714</c:v>
                </c:pt>
              </c:numCache>
            </c:numRef>
          </c:xVal>
          <c:yVal>
            <c:numRef>
              <c:f>'(6) ROC diagram'!$G$5:$K$5</c:f>
              <c:numCache>
                <c:formatCode>0.0</c:formatCode>
                <c:ptCount val="5"/>
                <c:pt idx="0">
                  <c:v>0.22413793103448276</c:v>
                </c:pt>
                <c:pt idx="1">
                  <c:v>7.3891625615763554E-2</c:v>
                </c:pt>
                <c:pt idx="2">
                  <c:v>0.27093596059113301</c:v>
                </c:pt>
                <c:pt idx="3">
                  <c:v>0.564039408866995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176C-9743-9BEB-22E9D9D68763}"/>
            </c:ext>
          </c:extLst>
        </c:ser>
        <c:ser>
          <c:idx val="2"/>
          <c:order val="2"/>
          <c:tx>
            <c:v>(C) Epigenetics, Immunology and Cancer Research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24549F"/>
              </a:solidFill>
              <a:ln w="38100">
                <a:solidFill>
                  <a:srgbClr val="24549F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Query 1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176C-9743-9BEB-22E9D9D68763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Query 2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176C-9743-9BEB-22E9D9D68763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Query 3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176C-9743-9BEB-22E9D9D68763}"/>
                </c:ext>
              </c:extLst>
            </c:dLbl>
            <c:dLbl>
              <c:idx val="3"/>
              <c:layout>
                <c:manualLayout>
                  <c:x val="-5.9600069455199224E-2"/>
                  <c:y val="-3.808365625244367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Query 4</a:t>
                    </a:r>
                  </a:p>
                </c:rich>
              </c:tx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176C-9743-9BEB-22E9D9D687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DE"/>
              </a:p>
            </c:txPr>
            <c:dLblPos val="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xVal>
            <c:numRef>
              <c:f>'(6) ROC diagram'!$L$4:$O$4</c:f>
              <c:numCache>
                <c:formatCode>0.0</c:formatCode>
                <c:ptCount val="4"/>
                <c:pt idx="0">
                  <c:v>0.77622950819672132</c:v>
                </c:pt>
                <c:pt idx="1">
                  <c:v>0.77622950819672132</c:v>
                </c:pt>
                <c:pt idx="2">
                  <c:v>0.82325581395348835</c:v>
                </c:pt>
                <c:pt idx="3">
                  <c:v>0.9116456299118838</c:v>
                </c:pt>
              </c:numCache>
            </c:numRef>
          </c:xVal>
          <c:yVal>
            <c:numRef>
              <c:f>'(6) ROC diagram'!$L$5:$O$5</c:f>
              <c:numCache>
                <c:formatCode>0.0</c:formatCode>
                <c:ptCount val="4"/>
                <c:pt idx="0">
                  <c:v>0.31093394077448749</c:v>
                </c:pt>
                <c:pt idx="1">
                  <c:v>0.15148063781321183</c:v>
                </c:pt>
                <c:pt idx="2">
                  <c:v>0.38952164009111617</c:v>
                </c:pt>
                <c:pt idx="3">
                  <c:v>0.845102505694760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176C-9743-9BEB-22E9D9D68763}"/>
            </c:ext>
          </c:extLst>
        </c:ser>
        <c:dLbls>
          <c:dLblPos val="r"/>
          <c:showLegendKey val="0"/>
          <c:showVal val="1"/>
          <c:showCatName val="0"/>
          <c:showSerName val="0"/>
          <c:showPercent val="0"/>
          <c:showBubbleSize val="0"/>
        </c:dLbls>
        <c:axId val="437242624"/>
        <c:axId val="437107792"/>
      </c:scatterChart>
      <c:valAx>
        <c:axId val="4372426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>
                    <a:solidFill>
                      <a:schemeClr val="tx1"/>
                    </a:solidFill>
                  </a:rPr>
                  <a:t>False Discovery Rate (FD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DE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DE"/>
          </a:p>
        </c:txPr>
        <c:crossAx val="437107792"/>
        <c:crosses val="autoZero"/>
        <c:crossBetween val="midCat"/>
        <c:majorUnit val="0.5"/>
      </c:valAx>
      <c:valAx>
        <c:axId val="437107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GB" sz="1000" b="0" i="0" u="none" strike="noStrike" kern="1200" baseline="0" noProof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noProof="0" dirty="0">
                    <a:solidFill>
                      <a:schemeClr val="tx1"/>
                    </a:solidFill>
                  </a:rPr>
                  <a:t>True positive rate = Sensitivity</a:t>
                </a:r>
                <a:r>
                  <a:rPr lang="en-GB" baseline="0" noProof="0" dirty="0">
                    <a:solidFill>
                      <a:schemeClr val="tx1"/>
                    </a:solidFill>
                  </a:rPr>
                  <a:t> </a:t>
                </a:r>
                <a:endParaRPr lang="en-GB" noProof="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GB" sz="1000" b="0" i="0" u="none" strike="noStrike" kern="1200" baseline="0" noProof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DE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DE"/>
          </a:p>
        </c:txPr>
        <c:crossAx val="437242624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GB" sz="1400" b="0" i="0" u="none" strike="noStrike" kern="1200" spc="0" baseline="0" noProof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noProof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Analysis and </a:t>
            </a:r>
          </a:p>
          <a:p>
            <a:pPr>
              <a:defRPr lang="en-GB" noProof="0">
                <a:solidFill>
                  <a:schemeClr val="tx1"/>
                </a:solidFill>
              </a:defRPr>
            </a:pPr>
            <a:r>
              <a:rPr lang="en-GB" b="1" noProof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tificial Intelligenc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GB" sz="1400" b="0" i="0" u="none" strike="noStrike" kern="1200" spc="0" baseline="0" noProof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(5) Figures &amp; Tabels I'!$B$4</c:f>
              <c:strCache>
                <c:ptCount val="1"/>
                <c:pt idx="0">
                  <c:v>Sensitivit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24549F"/>
              </a:solidFill>
              <a:ln w="38100">
                <a:solidFill>
                  <a:srgbClr val="24549F"/>
                </a:solidFill>
              </a:ln>
              <a:effectLst/>
            </c:spPr>
          </c:marker>
          <c:xVal>
            <c:multiLvlStrRef>
              <c:f>'(5) Figures &amp; Tabels I'!$G$2:$J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Data Analysis and Artificial Intelligence</c:v>
                  </c:pt>
                </c:lvl>
              </c:multiLvlStrCache>
            </c:multiLvlStrRef>
          </c:xVal>
          <c:yVal>
            <c:numRef>
              <c:f>'(5) Figures &amp; Tabels I'!$G$4:$J$4</c:f>
              <c:numCache>
                <c:formatCode>0.00%</c:formatCode>
                <c:ptCount val="4"/>
                <c:pt idx="0">
                  <c:v>0.22413793103448276</c:v>
                </c:pt>
                <c:pt idx="1">
                  <c:v>7.3891625615763554E-2</c:v>
                </c:pt>
                <c:pt idx="2">
                  <c:v>0.27093596059113301</c:v>
                </c:pt>
                <c:pt idx="3">
                  <c:v>0.564039408866995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21F-2F4F-9B00-172F60400698}"/>
            </c:ext>
          </c:extLst>
        </c:ser>
        <c:ser>
          <c:idx val="1"/>
          <c:order val="1"/>
          <c:tx>
            <c:strRef>
              <c:f>'(5) Figures &amp; Tabels I'!$B$5</c:f>
              <c:strCache>
                <c:ptCount val="1"/>
                <c:pt idx="0">
                  <c:v>False Discovery Rate (FDR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B22F38"/>
              </a:solidFill>
              <a:ln w="38100">
                <a:solidFill>
                  <a:srgbClr val="B22F38"/>
                </a:solidFill>
              </a:ln>
              <a:effectLst/>
            </c:spPr>
          </c:marker>
          <c:xVal>
            <c:multiLvlStrRef>
              <c:f>'(5) Figures &amp; Tabels I'!$G$2:$J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Data Analysis and Artificial Intelligence</c:v>
                  </c:pt>
                </c:lvl>
              </c:multiLvlStrCache>
            </c:multiLvlStrRef>
          </c:xVal>
          <c:yVal>
            <c:numRef>
              <c:f>'(5) Figures &amp; Tabels I'!$G$5:$J$5</c:f>
              <c:numCache>
                <c:formatCode>0.00%</c:formatCode>
                <c:ptCount val="4"/>
                <c:pt idx="0">
                  <c:v>0.89153754469606672</c:v>
                </c:pt>
                <c:pt idx="1">
                  <c:v>0.86956521739130432</c:v>
                </c:pt>
                <c:pt idx="2">
                  <c:v>0.89065606361829031</c:v>
                </c:pt>
                <c:pt idx="3">
                  <c:v>0.932686654908877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21F-2F4F-9B00-172F60400698}"/>
            </c:ext>
          </c:extLst>
        </c:ser>
        <c:ser>
          <c:idx val="2"/>
          <c:order val="2"/>
          <c:tx>
            <c:strRef>
              <c:f>'(5) Figures &amp; Tabels I'!$B$6</c:f>
              <c:strCache>
                <c:ptCount val="1"/>
                <c:pt idx="0">
                  <c:v>(Sens-FDR)+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38100">
                <a:solidFill>
                  <a:schemeClr val="accent3"/>
                </a:solidFill>
              </a:ln>
              <a:effectLst/>
            </c:spPr>
          </c:marker>
          <c:xVal>
            <c:multiLvlStrRef>
              <c:f>'(5) Figures &amp; Tabels I'!$G$2:$J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Data Analysis and Artificial Intelligence</c:v>
                  </c:pt>
                </c:lvl>
              </c:multiLvlStrCache>
            </c:multiLvlStrRef>
          </c:xVal>
          <c:yVal>
            <c:numRef>
              <c:f>'(5) Figures &amp; Tabels I'!$G$6:$J$6</c:f>
              <c:numCache>
                <c:formatCode>0.00%</c:formatCode>
                <c:ptCount val="4"/>
                <c:pt idx="0">
                  <c:v>0.33260038633841604</c:v>
                </c:pt>
                <c:pt idx="1">
                  <c:v>0.20432640822445924</c:v>
                </c:pt>
                <c:pt idx="2">
                  <c:v>0.3802798969728427</c:v>
                </c:pt>
                <c:pt idx="3">
                  <c:v>0.631352753958117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21F-2F4F-9B00-172F604006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6811520"/>
        <c:axId val="436813792"/>
      </c:scatterChart>
      <c:valAx>
        <c:axId val="436811520"/>
        <c:scaling>
          <c:orientation val="minMax"/>
          <c:max val="4.5"/>
          <c:min val="0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436813792"/>
        <c:crosses val="autoZero"/>
        <c:crossBetween val="midCat"/>
        <c:majorUnit val="1"/>
        <c:minorUnit val="0.1"/>
      </c:valAx>
      <c:valAx>
        <c:axId val="436813792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436811520"/>
        <c:crosses val="autoZero"/>
        <c:crossBetween val="midCat"/>
        <c:minorUnit val="0.0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 dirty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dirty="0"/>
      </a:pPr>
      <a:endParaRPr lang="en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igenetics,</a:t>
            </a:r>
            <a:r>
              <a:rPr lang="de-DE" sz="14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mmunology </a:t>
            </a:r>
          </a:p>
          <a:p>
            <a:pPr>
              <a:defRPr/>
            </a:pPr>
            <a:r>
              <a:rPr lang="de-DE" sz="14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Cancer Research</a:t>
            </a:r>
            <a:endParaRPr lang="de-DE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(5) Figures &amp; Tabels I'!$B$4</c:f>
              <c:strCache>
                <c:ptCount val="1"/>
                <c:pt idx="0">
                  <c:v>Sensitivit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24549F"/>
              </a:solidFill>
              <a:ln w="38100">
                <a:solidFill>
                  <a:srgbClr val="24549F"/>
                </a:solidFill>
              </a:ln>
              <a:effectLst/>
            </c:spPr>
          </c:marker>
          <c:xVal>
            <c:multiLvlStrRef>
              <c:f>'(5) Figures &amp; Tabels I'!$K$2:$N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Epigenetics, Immunology and Cancer Research</c:v>
                  </c:pt>
                </c:lvl>
              </c:multiLvlStrCache>
            </c:multiLvlStrRef>
          </c:xVal>
          <c:yVal>
            <c:numRef>
              <c:f>'(5) Figures &amp; Tabels I'!$K$4:$N$4</c:f>
              <c:numCache>
                <c:formatCode>0.00%</c:formatCode>
                <c:ptCount val="4"/>
                <c:pt idx="0">
                  <c:v>0.31093394077448749</c:v>
                </c:pt>
                <c:pt idx="1">
                  <c:v>0.15148063781321183</c:v>
                </c:pt>
                <c:pt idx="2">
                  <c:v>0.38952164009111617</c:v>
                </c:pt>
                <c:pt idx="3">
                  <c:v>0.845102505694760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33-A641-BB85-CBCE7B709987}"/>
            </c:ext>
          </c:extLst>
        </c:ser>
        <c:ser>
          <c:idx val="1"/>
          <c:order val="1"/>
          <c:tx>
            <c:strRef>
              <c:f>'(5) Figures &amp; Tabels I'!$B$5</c:f>
              <c:strCache>
                <c:ptCount val="1"/>
                <c:pt idx="0">
                  <c:v>False Discovery Rate (FDR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B22F38"/>
              </a:solidFill>
              <a:ln w="38100">
                <a:solidFill>
                  <a:srgbClr val="B22F38"/>
                </a:solidFill>
              </a:ln>
              <a:effectLst/>
            </c:spPr>
          </c:marker>
          <c:xVal>
            <c:multiLvlStrRef>
              <c:f>'(5) Figures &amp; Tabels I'!$K$2:$N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Epigenetics, Immunology and Cancer Research</c:v>
                  </c:pt>
                </c:lvl>
              </c:multiLvlStrCache>
            </c:multiLvlStrRef>
          </c:xVal>
          <c:yVal>
            <c:numRef>
              <c:f>'(5) Figures &amp; Tabels I'!$K$5:$N$5</c:f>
              <c:numCache>
                <c:formatCode>0.00%</c:formatCode>
                <c:ptCount val="4"/>
                <c:pt idx="0">
                  <c:v>0.77622950819672132</c:v>
                </c:pt>
                <c:pt idx="1">
                  <c:v>0.77622950819672132</c:v>
                </c:pt>
                <c:pt idx="2">
                  <c:v>0.82325581395348835</c:v>
                </c:pt>
                <c:pt idx="3">
                  <c:v>0.91164562991188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733-A641-BB85-CBCE7B709987}"/>
            </c:ext>
          </c:extLst>
        </c:ser>
        <c:ser>
          <c:idx val="2"/>
          <c:order val="2"/>
          <c:tx>
            <c:strRef>
              <c:f>'(5) Figures &amp; Tabels I'!$B$6</c:f>
              <c:strCache>
                <c:ptCount val="1"/>
                <c:pt idx="0">
                  <c:v>(Sens-FDR)+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38100">
                <a:solidFill>
                  <a:schemeClr val="accent3"/>
                </a:solidFill>
              </a:ln>
              <a:effectLst/>
            </c:spPr>
          </c:marker>
          <c:xVal>
            <c:multiLvlStrRef>
              <c:f>'(5) Figures &amp; Tabels I'!$K$2:$N$3</c:f>
              <c:multiLvlStrCache>
                <c:ptCount val="4"/>
                <c:lvl>
                  <c:pt idx="0">
                    <c:v>Query 1</c:v>
                  </c:pt>
                  <c:pt idx="1">
                    <c:v>Query 2</c:v>
                  </c:pt>
                  <c:pt idx="2">
                    <c:v>Query 3</c:v>
                  </c:pt>
                  <c:pt idx="3">
                    <c:v>Query 4</c:v>
                  </c:pt>
                </c:lvl>
                <c:lvl>
                  <c:pt idx="0">
                    <c:v>Epigenetics, Immunology and Cancer Research</c:v>
                  </c:pt>
                </c:lvl>
              </c:multiLvlStrCache>
            </c:multiLvlStrRef>
          </c:xVal>
          <c:yVal>
            <c:numRef>
              <c:f>'(5) Figures &amp; Tabels I'!$K$6:$N$6</c:f>
              <c:numCache>
                <c:formatCode>0.00%</c:formatCode>
                <c:ptCount val="4"/>
                <c:pt idx="0">
                  <c:v>0.53470443257776612</c:v>
                </c:pt>
                <c:pt idx="1">
                  <c:v>0.37525112961649054</c:v>
                </c:pt>
                <c:pt idx="2">
                  <c:v>0.56626582613762788</c:v>
                </c:pt>
                <c:pt idx="3">
                  <c:v>0.933456875782877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733-A641-BB85-CBCE7B7099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6878288"/>
        <c:axId val="436880288"/>
      </c:scatterChart>
      <c:valAx>
        <c:axId val="436878288"/>
        <c:scaling>
          <c:orientation val="minMax"/>
          <c:max val="4.5"/>
          <c:min val="0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436880288"/>
        <c:crosses val="autoZero"/>
        <c:crossBetween val="midCat"/>
        <c:majorUnit val="1"/>
        <c:minorUnit val="0.1"/>
      </c:valAx>
      <c:valAx>
        <c:axId val="436880288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436878288"/>
        <c:crosses val="autoZero"/>
        <c:crossBetween val="midCat"/>
        <c:minorUnit val="0.0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102EAF-BA1A-5E42-972C-3DA78D94390D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A310DB-E2B2-E84F-A33D-A6194A133BD6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76755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A310DB-E2B2-E84F-A33D-A6194A133BD6}" type="slidenum">
              <a:rPr lang="de-DE" smtClean="0"/>
              <a:t>5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194618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286073-9B80-32B1-B91B-9DBA5930ED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0027CC9-F56A-6291-D8CE-D4804E7C69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D97874-8BDA-0FC1-9728-63F9A2FE5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2C1DAB-89D9-8338-7021-05B58B051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6E44D18-CBDA-FC65-40A7-B413C36D5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45562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BA6E706-082E-992E-B5A4-F71FDE1D76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6DC9EA5-E8F8-7381-A206-CDC65D64CC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267666-D623-CD44-D7FF-EC7E04660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F999427-B10C-07E5-D130-9D2359833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17E15B9-9092-CD89-16A1-302B04FA9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01738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3CF4E8F-4CB2-65CB-9A3E-D7A562ABAF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97188C3-4B2E-B19D-5D9B-A178F880AE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B56BCFA-56B4-3D6C-D5B8-578089576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A3A8630-5083-A62A-E868-B50F97BE5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038F29-D696-8F34-1127-034A2F323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39225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64123F-DB76-02D7-4944-996E6A97A4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FBF8B04-6AFC-CC02-B770-28817417FC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7C75ED7-DAEA-2016-B7AA-149EA0924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D790CAC-A3E6-226C-7C36-4FD02FC9C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06BA066-F0B0-B21B-AFD7-139DC8D02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11410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9E6E19-62D7-A149-1C9B-09B836759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C52D304-DA8A-07D8-6475-C0AEA96837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5EC49A-6A12-7CED-8B97-D309939C2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6A4F29A-0AB1-39A3-9078-7A6AB0D1E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D125E43-A0AE-148B-8545-7C76333D1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85577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B2532A-02BE-E055-85A2-83F137F5A2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C9157F8-98A6-72A6-0307-97DE38AE61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FC745E6-0EE3-F55C-A4C7-727F2A3D5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3B067D1-0E6A-CB98-0C33-4010DD89D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31D2D8A-D1DB-F342-691A-451F6357A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3D54CC2-DFE7-2607-CE22-17C40BBC1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96187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597351-562C-4E37-D3CB-889B50DAA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1EBDD97-53DC-FD2F-2CC2-2F0CA5B762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9ACBFA1-61DC-8DEE-66FA-1123817AD6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FF05AF5-8F0B-521E-D3D6-C69FD7521D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A09B732-E557-556A-F070-2E0425640C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00306C9-6105-3CD2-A1F7-47FBC1688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29DB5B4-99E1-A79B-C112-2DBEDDB46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8514E14-B6E5-AC15-0510-E254AF6FF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16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30EA0CA-E944-41F4-17AC-3D51FC9D99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CCAA834-CAD6-DFCC-B7B2-56B5FF30A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A769CF15-BADA-2EEF-43C9-B5F07DBD3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452219B-E2B4-4CB5-3694-8D13DC041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778197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60AF8CB-2470-F29B-BA93-882EA425E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BE62C0E-D114-89AF-6E16-C9ABCC037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D672205-057E-946C-C3F5-BB584C967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66094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B322B0-DD8D-14EC-1B52-8C33B791B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1E81D1E-98D7-47E5-E715-1CC9A85ADF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9EDA6E6-42B1-8DB1-B30A-95A4380FF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7D4A31F-B3F5-206D-810D-55F6DCC36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E6EE5F3-6FBA-4A63-8829-FA22FBA0E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3D36680-B9C9-3C11-D8B6-BEFCA5D48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58029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7A74F5-8EFC-836D-C931-675DA52C5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CF25E41-90F8-7A63-803C-D92B2076EE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0FD2BF7-3C97-8C0F-58F2-9CFFDC6C5F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49ED90C-0D57-81D0-0193-69B41448A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6F00819-29C4-CFCD-8B12-5A0488A48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BCD637B-82B9-6031-0297-A5E15220D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15787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39DC052-8027-83F6-5066-476BA02F7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FFF8B90-7B94-B60E-4BC0-145E054CF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52056A-7667-7858-32E4-611AF9B7A4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F2E80-9854-5A44-8895-2C715DC1491A}" type="datetimeFigureOut">
              <a:rPr lang="de-DE" smtClean="0"/>
              <a:t>04.08.2024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5350334-7344-AB5D-4C1E-5A7DB4BD8F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E16CA62-17FC-A4DA-02C0-9F933DBCA9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EC295-8B8F-2A4F-B637-8A4345396B6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0516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Ein Bild, das Text, Screenshot, Farbigkeit, Design enthält.&#10;&#10;Automatisch generierte Beschreibung">
            <a:extLst>
              <a:ext uri="{FF2B5EF4-FFF2-40B4-BE49-F238E27FC236}">
                <a16:creationId xmlns:a16="http://schemas.microsoft.com/office/drawing/2014/main" id="{D8FB1D8F-D715-7851-2660-7B0B320A02B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2" t="3990" r="507" b="2312"/>
          <a:stretch/>
        </p:blipFill>
        <p:spPr>
          <a:xfrm>
            <a:off x="3046142" y="383887"/>
            <a:ext cx="5256000" cy="24620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 descr="Ein Bild, das Text, Screenshot, Farbigkeit, Design enthält.&#10;&#10;Automatisch generierte Beschreibung">
            <a:extLst>
              <a:ext uri="{FF2B5EF4-FFF2-40B4-BE49-F238E27FC236}">
                <a16:creationId xmlns:a16="http://schemas.microsoft.com/office/drawing/2014/main" id="{B289D703-3282-A7C4-9D18-80E66BF0DBA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76" t="2157" r="641" b="2580"/>
          <a:stretch/>
        </p:blipFill>
        <p:spPr>
          <a:xfrm>
            <a:off x="3046142" y="2965472"/>
            <a:ext cx="5256000" cy="245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967FB5A0-B81C-772F-07E3-EA953C5C467F}"/>
              </a:ext>
            </a:extLst>
          </p:cNvPr>
          <p:cNvSpPr/>
          <p:nvPr/>
        </p:nvSpPr>
        <p:spPr>
          <a:xfrm>
            <a:off x="7398327" y="2558473"/>
            <a:ext cx="843615" cy="219330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ERY 2</a:t>
            </a: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63060E6D-2BD7-0A38-7E8C-D1BFE0FB3DC5}"/>
              </a:ext>
            </a:extLst>
          </p:cNvPr>
          <p:cNvSpPr/>
          <p:nvPr/>
        </p:nvSpPr>
        <p:spPr>
          <a:xfrm>
            <a:off x="7398327" y="5116944"/>
            <a:ext cx="843615" cy="240453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ERY 4</a:t>
            </a:r>
          </a:p>
        </p:txBody>
      </p:sp>
      <p:sp>
        <p:nvSpPr>
          <p:cNvPr id="8" name="Textfeld 13">
            <a:extLst>
              <a:ext uri="{FF2B5EF4-FFF2-40B4-BE49-F238E27FC236}">
                <a16:creationId xmlns:a16="http://schemas.microsoft.com/office/drawing/2014/main" id="{314E5F4A-30A9-32DB-FD1A-E497EB5FFEE3}"/>
              </a:ext>
            </a:extLst>
          </p:cNvPr>
          <p:cNvSpPr txBox="1"/>
          <p:nvPr/>
        </p:nvSpPr>
        <p:spPr>
          <a:xfrm>
            <a:off x="3046142" y="5543768"/>
            <a:ext cx="5256000" cy="883409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I3: 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earch area (D) MAdLand </a:t>
            </a:r>
            <a:r>
              <a:rPr lang="en-US" kern="100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ERY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 (“better sensitivity”) vs. </a:t>
            </a:r>
            <a:r>
              <a:rPr lang="en-US" kern="100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ERY</a:t>
            </a:r>
            <a:r>
              <a:rPr lang="en-US" sz="1100" kern="1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4 (“better specificity”) at the level of WoS Citation Topics Meso. Q</a:t>
            </a:r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ERY 4 is more specific compared to QUERY 2, as can be seen from the lack of medical research terms that are not part of research area D.</a:t>
            </a:r>
            <a:endParaRPr lang="de-DE" dirty="0">
              <a:solidFill>
                <a:schemeClr val="tx1"/>
              </a:solidFill>
            </a:endParaRPr>
          </a:p>
          <a:p>
            <a:endParaRPr lang="de-DE" sz="1100" kern="1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0601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1D209E62-1BED-17D8-473C-D72B0549B1BA}"/>
              </a:ext>
            </a:extLst>
          </p:cNvPr>
          <p:cNvGrpSpPr/>
          <p:nvPr/>
        </p:nvGrpSpPr>
        <p:grpSpPr>
          <a:xfrm>
            <a:off x="1537019" y="418339"/>
            <a:ext cx="9117957" cy="5059269"/>
            <a:chOff x="1537021" y="2329823"/>
            <a:chExt cx="9117957" cy="5059269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90DD5583-0C1A-3A8E-6966-6F0A3C2C381E}"/>
                </a:ext>
              </a:extLst>
            </p:cNvPr>
            <p:cNvSpPr txBox="1"/>
            <p:nvPr/>
          </p:nvSpPr>
          <p:spPr>
            <a:xfrm>
              <a:off x="1537021" y="2329823"/>
              <a:ext cx="9117957" cy="14619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S=bone AND TS=marrow) OR (TS=asthma AND TS=exacerbations) OR (TS=immune AND TS=cell) OR (TS=stromal  AND TS=cells) OR (TS=human AND TS=liver) OR (TS=ovarian AND TS=cancer) OR (TS=tumor AND TS=cells) OR (TS=cancer AND TS=cell) OR (TS=ko AND TS=mice) OR (TS=endocrine AND TS=hypertension) OR (TS=fracture AND TS=healing) OR (TS=galtkohcd AND TS=lungs) OR (TS=liver AND TS=tissue) OR (TS=aggregated AND TS=huntingtin) OR (TS=animal AND TS=models) OR (TS=cancer-induced AND TS=bone) OR (TS=huntingtin AND TS=aggregation) OR (TS=immune AND TS=response) OR (TS=immune AND TS=system) OR (TS=inflammatory AND TS=response) OR (TS=liver AND TS=disease) OR (TS=liver AND TS=stromal) OR (TS=lung AND TS=cancer) OR (TS=power AND TS=athlete) OR (TS=stromal-myeloid AND TS=coculture) OR (TS=therapeutic OR TS=target) OR (TS=tumor AND TS=cell) OR (TS=tumor AND TS=microenvironment) OR </a:t>
              </a:r>
              <a:r>
                <a:rPr lang="en-GB" sz="1100" dirty="0">
                  <a:solidFill>
                    <a:srgbClr val="0054A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TS=titanium) OR (TS=nickel) OR (TS=crystal*) OR (TS=carbide) OR (TS=reaction) OR (TS=zinc</a:t>
              </a:r>
              <a:r>
                <a:rPr lang="en-GB" sz="1200" dirty="0">
                  <a:solidFill>
                    <a:srgbClr val="0054A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4" name="Textfeld 13">
              <a:extLst>
                <a:ext uri="{FF2B5EF4-FFF2-40B4-BE49-F238E27FC236}">
                  <a16:creationId xmlns:a16="http://schemas.microsoft.com/office/drawing/2014/main" id="{A425D25B-969A-59B3-6E2E-E5A10EE6B292}"/>
                </a:ext>
              </a:extLst>
            </p:cNvPr>
            <p:cNvSpPr txBox="1"/>
            <p:nvPr/>
          </p:nvSpPr>
          <p:spPr>
            <a:xfrm>
              <a:off x="3542031" y="6393447"/>
              <a:ext cx="5256000" cy="995645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ble SI4: 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st of unigram (a) and bigram (b) NOT operator terms to reduce medical and other off-topic literature in the research area (D</a:t>
              </a:r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 MAdLand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Marked in </a:t>
              </a:r>
              <a:r>
                <a:rPr lang="en-US" dirty="0">
                  <a:solidFill>
                    <a:srgbClr val="0054A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lue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additional terms that have been added by expert review of the random samples. (</a:t>
              </a:r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 Comparison of hits, TP, FN and sensitivity depending on the configuration of the query regarding research area (D), Category MAdLand (2021-2022) with unigrams.</a:t>
              </a:r>
            </a:p>
            <a:p>
              <a:endParaRPr lang="en-GB" sz="1100" b="0" baseline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FA0FDE59-4D3D-26ED-C91A-B850A4FD3C0B}"/>
                </a:ext>
              </a:extLst>
            </p:cNvPr>
            <p:cNvSpPr txBox="1"/>
            <p:nvPr/>
          </p:nvSpPr>
          <p:spPr>
            <a:xfrm>
              <a:off x="1537021" y="3963289"/>
              <a:ext cx="9117956" cy="93871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</a:t>
              </a:r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S=bone marrow OR TS=asthma exacerbations OR TS=immune cell OR TS=stromal cells OR TS=human liver OR TS=ovarian cancer OR TS=tumor cells OR TS=cancer cell OR TS=ko mice OR TS=endocrine hypertension OR TS=fracture healing OR TS=galtkohcd lungs OR TS=liver tissue OR TS=aggregated huntingtin OR TS=animal models OR TS=aggregated huntingtin OR TS=animal models OR TS=cancer-induced bone OR TS=huntingtin aggregation OR TS=immune response OR TS=immune system OR TS=inflammatory response OR TS=liver disease OR TS=liver stromal OR TS=lung cancer OR TS=power athlete OR TS=stromal-myeloid coculture OR TS=therapeutic target OR TS=tumor cell OR TS=tumor microenvironment</a:t>
              </a:r>
            </a:p>
          </p:txBody>
        </p:sp>
      </p:grp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05B460E8-C0A5-4BF6-7CA4-57A57D42D9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3536927"/>
              </p:ext>
            </p:extLst>
          </p:nvPr>
        </p:nvGraphicFramePr>
        <p:xfrm>
          <a:off x="1716251" y="3442027"/>
          <a:ext cx="8938724" cy="8509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751676">
                  <a:extLst>
                    <a:ext uri="{9D8B030D-6E8A-4147-A177-3AD203B41FA5}">
                      <a16:colId xmlns:a16="http://schemas.microsoft.com/office/drawing/2014/main" val="2659936649"/>
                    </a:ext>
                  </a:extLst>
                </a:gridCol>
                <a:gridCol w="1594796">
                  <a:extLst>
                    <a:ext uri="{9D8B030D-6E8A-4147-A177-3AD203B41FA5}">
                      <a16:colId xmlns:a16="http://schemas.microsoft.com/office/drawing/2014/main" val="1241747301"/>
                    </a:ext>
                  </a:extLst>
                </a:gridCol>
                <a:gridCol w="1361579">
                  <a:extLst>
                    <a:ext uri="{9D8B030D-6E8A-4147-A177-3AD203B41FA5}">
                      <a16:colId xmlns:a16="http://schemas.microsoft.com/office/drawing/2014/main" val="1696226555"/>
                    </a:ext>
                  </a:extLst>
                </a:gridCol>
                <a:gridCol w="1429176">
                  <a:extLst>
                    <a:ext uri="{9D8B030D-6E8A-4147-A177-3AD203B41FA5}">
                      <a16:colId xmlns:a16="http://schemas.microsoft.com/office/drawing/2014/main" val="3516494328"/>
                    </a:ext>
                  </a:extLst>
                </a:gridCol>
                <a:gridCol w="801497">
                  <a:extLst>
                    <a:ext uri="{9D8B030D-6E8A-4147-A177-3AD203B41FA5}">
                      <a16:colId xmlns:a16="http://schemas.microsoft.com/office/drawing/2014/main" val="292046945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</a:t>
                      </a:r>
                      <a:r>
                        <a:rPr lang="en-GB" sz="12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GB" sz="12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ts, Region: Germany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 Positives (TP)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lse Negatives (FN)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</a:t>
                      </a:r>
                      <a:r>
                        <a:rPr lang="de-DE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19231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4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16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,7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417751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4 "NOT"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47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,76%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881481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</a:t>
                      </a:r>
                      <a:r>
                        <a:rPr lang="en-GB" sz="12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"NOT" without </a:t>
                      </a:r>
                      <a:r>
                        <a:rPr lang="en-GB" sz="1200" u="none" strike="noStrike" noProof="0" dirty="0">
                          <a:solidFill>
                            <a:srgbClr val="0054A6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ditional terms </a:t>
                      </a:r>
                      <a:r>
                        <a:rPr lang="en-GB" sz="12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f. Table SI2(a))</a:t>
                      </a:r>
                      <a:endParaRPr lang="en-GB" sz="12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62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,58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9749438"/>
                  </a:ext>
                </a:extLst>
              </a:tr>
            </a:tbl>
          </a:graphicData>
        </a:graphic>
      </p:graphicFrame>
      <p:sp>
        <p:nvSpPr>
          <p:cNvPr id="8" name="Textfeld 13">
            <a:extLst>
              <a:ext uri="{FF2B5EF4-FFF2-40B4-BE49-F238E27FC236}">
                <a16:creationId xmlns:a16="http://schemas.microsoft.com/office/drawing/2014/main" id="{FDE068E8-0328-4A83-B578-D89DF4E896C6}"/>
              </a:ext>
            </a:extLst>
          </p:cNvPr>
          <p:cNvSpPr txBox="1"/>
          <p:nvPr/>
        </p:nvSpPr>
        <p:spPr>
          <a:xfrm>
            <a:off x="1546350" y="3129997"/>
            <a:ext cx="1995679" cy="245987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en-GB" sz="1100" b="0" baseline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283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13">
            <a:extLst>
              <a:ext uri="{FF2B5EF4-FFF2-40B4-BE49-F238E27FC236}">
                <a16:creationId xmlns:a16="http://schemas.microsoft.com/office/drawing/2014/main" id="{6D0C2DCD-0747-445D-940B-B48E0ECAD628}"/>
              </a:ext>
            </a:extLst>
          </p:cNvPr>
          <p:cNvSpPr txBox="1"/>
          <p:nvPr/>
        </p:nvSpPr>
        <p:spPr>
          <a:xfrm>
            <a:off x="378957" y="6075301"/>
            <a:ext cx="9447630" cy="524933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GB" sz="1100" b="1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1: </a:t>
            </a:r>
            <a:r>
              <a:rPr lang="en-GB" sz="110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solut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lative frequencies of terms derived from the training data set word count analysis for the research areas (A)-(D).</a:t>
            </a:r>
          </a:p>
          <a:p>
            <a:pPr algn="ctr"/>
            <a:r>
              <a:rPr lang="en-US" sz="1100" b="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/max/aver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 values are based on the terms shown; 95% quartile is based on the training data word count for the respective research area.</a:t>
            </a:r>
            <a:endParaRPr lang="en-GB" sz="1100" b="0" baseline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elle 1">
            <a:extLst>
              <a:ext uri="{FF2B5EF4-FFF2-40B4-BE49-F238E27FC236}">
                <a16:creationId xmlns:a16="http://schemas.microsoft.com/office/drawing/2014/main" id="{22CEE671-438C-48D1-836C-A249F234F6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4600048"/>
              </p:ext>
            </p:extLst>
          </p:nvPr>
        </p:nvGraphicFramePr>
        <p:xfrm>
          <a:off x="497246" y="653800"/>
          <a:ext cx="2365200" cy="529084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88400">
                  <a:extLst>
                    <a:ext uri="{9D8B030D-6E8A-4147-A177-3AD203B41FA5}">
                      <a16:colId xmlns:a16="http://schemas.microsoft.com/office/drawing/2014/main" val="1313873318"/>
                    </a:ext>
                  </a:extLst>
                </a:gridCol>
                <a:gridCol w="788400">
                  <a:extLst>
                    <a:ext uri="{9D8B030D-6E8A-4147-A177-3AD203B41FA5}">
                      <a16:colId xmlns:a16="http://schemas.microsoft.com/office/drawing/2014/main" val="69418793"/>
                    </a:ext>
                  </a:extLst>
                </a:gridCol>
                <a:gridCol w="788400">
                  <a:extLst>
                    <a:ext uri="{9D8B030D-6E8A-4147-A177-3AD203B41FA5}">
                      <a16:colId xmlns:a16="http://schemas.microsoft.com/office/drawing/2014/main" val="3145101910"/>
                    </a:ext>
                  </a:extLst>
                </a:gridCol>
              </a:tblGrid>
              <a:tr h="155753">
                <a:tc gridSpan="3">
                  <a:txBody>
                    <a:bodyPr/>
                    <a:lstStyle/>
                    <a:p>
                      <a:pPr marL="228600" indent="-228600" algn="ctr" fontAlgn="b">
                        <a:buAutoNum type="alphaUcParenBoth"/>
                      </a:pPr>
                      <a:r>
                        <a:rPr lang="en-GB" sz="10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genetics, Immunology and Cancer Research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9279675"/>
                  </a:ext>
                </a:extLst>
              </a:tr>
              <a:tr h="225730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4</a:t>
                      </a:r>
                    </a:p>
                  </a:txBody>
                  <a:tcPr marL="7301" marR="7301" marT="73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1061381"/>
                  </a:ext>
                </a:extLst>
              </a:tr>
              <a:tr h="759294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S=gen* AND TS=cell) OR (TS=patient OR TS=expression OR TS=immune OR TS=human OR TS=infection OR TS=CD8 OR TS=disease OR TS=virus OR TS=antigen OR TS=clinical OR TS=receptor OR TS=mutation OR TS=treatment) AND PY=(2019-2022)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5919185"/>
                  </a:ext>
                </a:extLst>
              </a:tr>
              <a:tr h="155753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1334998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5850765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67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0778705"/>
                  </a:ext>
                </a:extLst>
              </a:tr>
              <a:tr h="155753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978005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8667789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78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56614477"/>
                  </a:ext>
                </a:extLst>
              </a:tr>
              <a:tr h="155753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Quartile: 9</a:t>
                      </a: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7487253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3051353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*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0001111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4807511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4926349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12014105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3850074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2748692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ection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26623845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4561769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4623152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902874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gen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8350343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ical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52626973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ptor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73067310"/>
                  </a:ext>
                </a:extLst>
              </a:tr>
              <a:tr h="155753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1038722"/>
                  </a:ext>
                </a:extLst>
              </a:tr>
              <a:tr h="16548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01" marR="7301" marT="7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%</a:t>
                      </a:r>
                    </a:p>
                  </a:txBody>
                  <a:tcPr marL="7301" marR="7301" marT="7301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6417244"/>
                  </a:ext>
                </a:extLst>
              </a:tr>
            </a:tbl>
          </a:graphicData>
        </a:graphic>
      </p:graphicFrame>
      <p:graphicFrame>
        <p:nvGraphicFramePr>
          <p:cNvPr id="9" name="Tabelle 5">
            <a:extLst>
              <a:ext uri="{FF2B5EF4-FFF2-40B4-BE49-F238E27FC236}">
                <a16:creationId xmlns:a16="http://schemas.microsoft.com/office/drawing/2014/main" id="{1C7BE64E-9D09-4294-A597-9E5A73DCF8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8217454"/>
              </p:ext>
            </p:extLst>
          </p:nvPr>
        </p:nvGraphicFramePr>
        <p:xfrm>
          <a:off x="3007181" y="645132"/>
          <a:ext cx="2379636" cy="530599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65603">
                  <a:extLst>
                    <a:ext uri="{9D8B030D-6E8A-4147-A177-3AD203B41FA5}">
                      <a16:colId xmlns:a16="http://schemas.microsoft.com/office/drawing/2014/main" val="2561931761"/>
                    </a:ext>
                  </a:extLst>
                </a:gridCol>
                <a:gridCol w="765603">
                  <a:extLst>
                    <a:ext uri="{9D8B030D-6E8A-4147-A177-3AD203B41FA5}">
                      <a16:colId xmlns:a16="http://schemas.microsoft.com/office/drawing/2014/main" val="1602805190"/>
                    </a:ext>
                  </a:extLst>
                </a:gridCol>
                <a:gridCol w="848430">
                  <a:extLst>
                    <a:ext uri="{9D8B030D-6E8A-4147-A177-3AD203B41FA5}">
                      <a16:colId xmlns:a16="http://schemas.microsoft.com/office/drawing/2014/main" val="2457469346"/>
                    </a:ext>
                  </a:extLst>
                </a:gridCol>
              </a:tblGrid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) Data Analysis and </a:t>
                      </a:r>
                    </a:p>
                    <a:p>
                      <a:pPr algn="ctr" fontAlgn="b"/>
                      <a:r>
                        <a:rPr lang="en-GB" sz="10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ificial Intelligence 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296283"/>
                  </a:ext>
                </a:extLst>
              </a:tr>
              <a:tr h="234431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4 </a:t>
                      </a: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8351343"/>
                  </a:ext>
                </a:extLst>
              </a:tr>
              <a:tr h="755912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S=data and TS=model) OR (TS=deep OR TS=*learning OR TS=networks OR TS=framework OR TS=network OR TS=algorithm OR TS=neural OR TS=benchmark OR TS=machine OR TS=KI OR TS=artificial) AND PY=(2019-2022)</a:t>
                      </a:r>
                    </a:p>
                    <a:p>
                      <a:pPr algn="l" fontAlgn="ctr"/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7233917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755152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962761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6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469348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216569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567213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00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8105476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Quartile: 6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897200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</a:t>
                      </a:r>
                      <a:r>
                        <a:rPr lang="en-GB" sz="1000" u="none" strike="noStrike" noProof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1722943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894514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learning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33904179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p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8306753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2520979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mework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8189088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al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253406402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gorithm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%</a:t>
                      </a: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601320424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twork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788188127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ificial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6796751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hine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6027317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chmark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3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%</a:t>
                      </a: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21576087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2455759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l" fontAlgn="b"/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67425328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4443411"/>
                  </a:ext>
                </a:extLst>
              </a:tr>
            </a:tbl>
          </a:graphicData>
        </a:graphic>
      </p:graphicFrame>
      <p:graphicFrame>
        <p:nvGraphicFramePr>
          <p:cNvPr id="10" name="Tabelle 6">
            <a:extLst>
              <a:ext uri="{FF2B5EF4-FFF2-40B4-BE49-F238E27FC236}">
                <a16:creationId xmlns:a16="http://schemas.microsoft.com/office/drawing/2014/main" id="{2E7CD419-AFE7-4840-811D-D0AFEAC6CE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346166"/>
              </p:ext>
            </p:extLst>
          </p:nvPr>
        </p:nvGraphicFramePr>
        <p:xfrm>
          <a:off x="5531261" y="653800"/>
          <a:ext cx="2354955" cy="531589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84985">
                  <a:extLst>
                    <a:ext uri="{9D8B030D-6E8A-4147-A177-3AD203B41FA5}">
                      <a16:colId xmlns:a16="http://schemas.microsoft.com/office/drawing/2014/main" val="2451723091"/>
                    </a:ext>
                  </a:extLst>
                </a:gridCol>
                <a:gridCol w="784985">
                  <a:extLst>
                    <a:ext uri="{9D8B030D-6E8A-4147-A177-3AD203B41FA5}">
                      <a16:colId xmlns:a16="http://schemas.microsoft.com/office/drawing/2014/main" val="620548413"/>
                    </a:ext>
                  </a:extLst>
                </a:gridCol>
                <a:gridCol w="784985">
                  <a:extLst>
                    <a:ext uri="{9D8B030D-6E8A-4147-A177-3AD203B41FA5}">
                      <a16:colId xmlns:a16="http://schemas.microsoft.com/office/drawing/2014/main" val="3061399525"/>
                    </a:ext>
                  </a:extLst>
                </a:gridCol>
              </a:tblGrid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) Complexity of Nature and Future Ecosystem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2315812"/>
                  </a:ext>
                </a:extLst>
              </a:tr>
              <a:tr h="23198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4 </a:t>
                      </a: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8733914"/>
                  </a:ext>
                </a:extLst>
              </a:tr>
              <a:tr h="755912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(TS=bio* and TS=eco*) OR (TS=species OR TS=forest OR TS=tree OR TS=root OR TS=biodiversity OR TS=plant* OR TS=soil OR TS=insect OR TS=nutrition OR TS=root OR TS=auxin))</a:t>
                      </a:r>
                    </a:p>
                    <a:p>
                      <a:pPr algn="l" fontAlgn="ctr"/>
                      <a:endParaRPr lang="en-GB" sz="1000" u="none" strike="noStrike" noProof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 fontAlgn="ctr"/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7040215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958399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758862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2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240078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uencies</a:t>
                      </a:r>
                      <a:r>
                        <a:rPr lang="en-GB" sz="10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3110909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6832104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384982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Quartile: 7 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2479124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 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4038456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 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7228379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*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3449838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est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3798075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*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%</a:t>
                      </a: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347680641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e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26657265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ot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90029435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diversity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2044502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t*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5100986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xin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90758670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il 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6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35507511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trition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227295712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ects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768520607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u="none" strike="noStrike" noProof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81270368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u="none" strike="noStrike" noProof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655822661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u="none" strike="noStrike" noProof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8114828"/>
                  </a:ext>
                </a:extLst>
              </a:tr>
            </a:tbl>
          </a:graphicData>
        </a:graphic>
      </p:graphicFrame>
      <p:graphicFrame>
        <p:nvGraphicFramePr>
          <p:cNvPr id="11" name="Tabelle 7">
            <a:extLst>
              <a:ext uri="{FF2B5EF4-FFF2-40B4-BE49-F238E27FC236}">
                <a16:creationId xmlns:a16="http://schemas.microsoft.com/office/drawing/2014/main" id="{98F310DF-368A-4CC6-AE17-022DBD3D8D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8580987"/>
              </p:ext>
            </p:extLst>
          </p:nvPr>
        </p:nvGraphicFramePr>
        <p:xfrm>
          <a:off x="7986538" y="645132"/>
          <a:ext cx="2296809" cy="532683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65603">
                  <a:extLst>
                    <a:ext uri="{9D8B030D-6E8A-4147-A177-3AD203B41FA5}">
                      <a16:colId xmlns:a16="http://schemas.microsoft.com/office/drawing/2014/main" val="2464688641"/>
                    </a:ext>
                  </a:extLst>
                </a:gridCol>
                <a:gridCol w="765603">
                  <a:extLst>
                    <a:ext uri="{9D8B030D-6E8A-4147-A177-3AD203B41FA5}">
                      <a16:colId xmlns:a16="http://schemas.microsoft.com/office/drawing/2014/main" val="3846655932"/>
                    </a:ext>
                  </a:extLst>
                </a:gridCol>
                <a:gridCol w="765603">
                  <a:extLst>
                    <a:ext uri="{9D8B030D-6E8A-4147-A177-3AD203B41FA5}">
                      <a16:colId xmlns:a16="http://schemas.microsoft.com/office/drawing/2014/main" val="2405960535"/>
                    </a:ext>
                  </a:extLst>
                </a:gridCol>
              </a:tblGrid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D) MAdLand </a:t>
                      </a:r>
                    </a:p>
                    <a:p>
                      <a:pPr algn="ctr" fontAlgn="b"/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7227987"/>
                  </a:ext>
                </a:extLst>
              </a:tr>
              <a:tr h="253092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y 2 </a:t>
                      </a: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5171802"/>
                  </a:ext>
                </a:extLst>
              </a:tr>
              <a:tr h="755912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S=plant AND TS=gene*) OR (TS=land OR TS=alga* OR TS=terrest* OR TS=cell OR TS=organ* OR TS=protein OR TS=signal* OR TS=evolution)</a:t>
                      </a:r>
                    </a:p>
                    <a:p>
                      <a:pPr algn="l" fontAlgn="ctr"/>
                      <a:endParaRPr lang="en-GB" sz="1000" b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 fontAlgn="ctr"/>
                      <a:endParaRPr lang="en-GB" sz="1000" b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 fontAlgn="ctr"/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3542624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frequencies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185275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86392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50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0945582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uencies</a:t>
                      </a:r>
                      <a:r>
                        <a:rPr lang="en-GB" sz="10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64443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-valu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-value</a:t>
                      </a:r>
                      <a:endParaRPr lang="en-GB" sz="1000" b="1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918659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50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589887"/>
                  </a:ext>
                </a:extLst>
              </a:tr>
              <a:tr h="155059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Quartile: 7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4313775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olute </a:t>
                      </a:r>
                      <a:r>
                        <a:rPr lang="en-GB" sz="1000" u="none" strike="noStrike" noProof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freq.</a:t>
                      </a:r>
                      <a:endParaRPr lang="en-GB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164969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*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79617077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t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76815948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nd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280143473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olution</a:t>
                      </a: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%</a:t>
                      </a: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97208021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ga*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466265029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rest*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54159690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07550073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*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025544691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9238113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*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90188269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40000191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96017380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489527632"/>
                  </a:ext>
                </a:extLst>
              </a:tr>
              <a:tr h="15505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00113231"/>
                  </a:ext>
                </a:extLst>
              </a:tr>
              <a:tr h="16475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>
                          <a:effectLst/>
                        </a:rPr>
                        <a:t> 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noProof="0" dirty="0">
                          <a:effectLst/>
                        </a:rPr>
                        <a:t> 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68" marR="7268" marT="726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3176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0759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3CE10A12-58CF-DD35-5125-6768A7178AB5}"/>
              </a:ext>
            </a:extLst>
          </p:cNvPr>
          <p:cNvGrpSpPr/>
          <p:nvPr/>
        </p:nvGrpSpPr>
        <p:grpSpPr>
          <a:xfrm>
            <a:off x="4018368" y="1192833"/>
            <a:ext cx="4155263" cy="4907822"/>
            <a:chOff x="2299296" y="1305128"/>
            <a:chExt cx="4155263" cy="4907822"/>
          </a:xfrm>
        </p:grpSpPr>
        <p:sp>
          <p:nvSpPr>
            <p:cNvPr id="3" name="Textfeld 13">
              <a:extLst>
                <a:ext uri="{FF2B5EF4-FFF2-40B4-BE49-F238E27FC236}">
                  <a16:creationId xmlns:a16="http://schemas.microsoft.com/office/drawing/2014/main" id="{4A307C1B-6343-9675-66E8-4E19014BF848}"/>
                </a:ext>
              </a:extLst>
            </p:cNvPr>
            <p:cNvSpPr txBox="1"/>
            <p:nvPr/>
          </p:nvSpPr>
          <p:spPr>
            <a:xfrm>
              <a:off x="2340693" y="5688017"/>
              <a:ext cx="4072467" cy="524933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</a:t>
              </a:r>
              <a:r>
                <a:rPr lang="en-GB" sz="1100" b="1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2: </a:t>
              </a:r>
              <a:r>
                <a:rPr lang="en-GB" sz="1100" b="0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C-like diagram for the queries with unigrams for the research areas (A), (B) and (C) for </a:t>
              </a:r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ERY</a:t>
              </a:r>
              <a:r>
                <a:rPr lang="en-GB" sz="1100" b="0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-4.</a:t>
              </a:r>
            </a:p>
          </p:txBody>
        </p:sp>
        <p:graphicFrame>
          <p:nvGraphicFramePr>
            <p:cNvPr id="4" name="Diagramm 3">
              <a:extLst>
                <a:ext uri="{FF2B5EF4-FFF2-40B4-BE49-F238E27FC236}">
                  <a16:creationId xmlns:a16="http://schemas.microsoft.com/office/drawing/2014/main" id="{BD3BF82C-AB7C-5894-BC4A-6291DC715A8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6861914"/>
                </p:ext>
              </p:extLst>
            </p:nvPr>
          </p:nvGraphicFramePr>
          <p:xfrm>
            <a:off x="2299296" y="1305128"/>
            <a:ext cx="4155263" cy="42536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D8D75711-AF64-4ECD-2B3F-A01DE397445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26209" y="1711866"/>
              <a:ext cx="90000" cy="90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3918AAA8-E040-3A27-E880-5C241BF76BA4}"/>
                </a:ext>
              </a:extLst>
            </p:cNvPr>
            <p:cNvSpPr txBox="1"/>
            <p:nvPr/>
          </p:nvSpPr>
          <p:spPr>
            <a:xfrm>
              <a:off x="2557661" y="1801866"/>
              <a:ext cx="6270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fect </a:t>
              </a:r>
            </a:p>
            <a:p>
              <a:pPr algn="ctr"/>
              <a:r>
                <a: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ifi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47780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EB524794-CC11-49BD-FB74-77E06E3EE9AB}"/>
              </a:ext>
            </a:extLst>
          </p:cNvPr>
          <p:cNvGrpSpPr/>
          <p:nvPr/>
        </p:nvGrpSpPr>
        <p:grpSpPr>
          <a:xfrm>
            <a:off x="1622425" y="6201063"/>
            <a:ext cx="8979456" cy="656937"/>
            <a:chOff x="1131394" y="5850058"/>
            <a:chExt cx="8979456" cy="656937"/>
          </a:xfrm>
        </p:grpSpPr>
        <p:sp>
          <p:nvSpPr>
            <p:cNvPr id="3" name="Textfeld 14">
              <a:extLst>
                <a:ext uri="{FF2B5EF4-FFF2-40B4-BE49-F238E27FC236}">
                  <a16:creationId xmlns:a16="http://schemas.microsoft.com/office/drawing/2014/main" id="{65710DCF-DD5C-994F-40DA-915561844484}"/>
                </a:ext>
              </a:extLst>
            </p:cNvPr>
            <p:cNvSpPr txBox="1"/>
            <p:nvPr/>
          </p:nvSpPr>
          <p:spPr>
            <a:xfrm>
              <a:off x="1131394" y="5850058"/>
              <a:ext cx="4335602" cy="652379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I3:</a:t>
              </a:r>
              <a:r>
                <a:rPr lang="en-GB" sz="1100" b="1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 and False Discovery Rate (FDR) and (Sens-FDR)+1 of the research area (B) "Data Analysis and Artificial Intelligence"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feld 17">
              <a:extLst>
                <a:ext uri="{FF2B5EF4-FFF2-40B4-BE49-F238E27FC236}">
                  <a16:creationId xmlns:a16="http://schemas.microsoft.com/office/drawing/2014/main" id="{CBE7D224-547D-D142-B986-2018CCB1AA73}"/>
                </a:ext>
              </a:extLst>
            </p:cNvPr>
            <p:cNvSpPr txBox="1"/>
            <p:nvPr/>
          </p:nvSpPr>
          <p:spPr>
            <a:xfrm>
              <a:off x="5744864" y="5850058"/>
              <a:ext cx="4365986" cy="656937"/>
            </a:xfrm>
            <a:prstGeom prst="rect">
              <a:avLst/>
            </a:prstGeom>
            <a:solidFill>
              <a:schemeClr val="lt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1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I4:</a:t>
              </a:r>
              <a:r>
                <a:rPr lang="en-GB" sz="1100" b="0" baseline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100" b="0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 and False Discovery Rate (FDR) and (Sens-FDR)+1 of the research area (A) "Epigenetics, Immunology and Cancer Research"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419B862D-CA9A-B6C2-721C-5DD34811E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3504242"/>
              </p:ext>
            </p:extLst>
          </p:nvPr>
        </p:nvGraphicFramePr>
        <p:xfrm>
          <a:off x="1590118" y="856997"/>
          <a:ext cx="4346711" cy="5375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:a16="http://schemas.microsoft.com/office/drawing/2014/main" id="{1D3CD99F-B969-6C81-51AB-C001771D92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5817505"/>
              </p:ext>
            </p:extLst>
          </p:nvPr>
        </p:nvGraphicFramePr>
        <p:xfrm>
          <a:off x="6301846" y="856997"/>
          <a:ext cx="4300035" cy="5340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218822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69</Words>
  <Application>Microsoft Office PowerPoint</Application>
  <PresentationFormat>Widescreen</PresentationFormat>
  <Paragraphs>30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m Streeb</dc:creator>
  <cp:lastModifiedBy>Stefan Rensing</cp:lastModifiedBy>
  <cp:revision>48</cp:revision>
  <dcterms:created xsi:type="dcterms:W3CDTF">2023-05-01T20:23:17Z</dcterms:created>
  <dcterms:modified xsi:type="dcterms:W3CDTF">2024-08-04T14:17:42Z</dcterms:modified>
</cp:coreProperties>
</file>